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58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623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873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45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551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102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191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877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0631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9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71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576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81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8DE1177-A61A-7AD0-39DC-A974AD2592FC}"/>
              </a:ext>
            </a:extLst>
          </p:cNvPr>
          <p:cNvSpPr txBox="1"/>
          <p:nvPr/>
        </p:nvSpPr>
        <p:spPr>
          <a:xfrm>
            <a:off x="251860" y="5207238"/>
            <a:ext cx="8640279" cy="1750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4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Hazards model for OS TNBC treated with ICIs. 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S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as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otted by hazards model in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TNBC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ime is presented as days from the start of immunotherapy. Patients are stratified by HER-2. Blue lines: HER-2 (-); red lines, HER-2 (1+/2+).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 descr="图表, 直方图&#10;&#10;描述已自动生成">
            <a:extLst>
              <a:ext uri="{FF2B5EF4-FFF2-40B4-BE49-F238E27FC236}">
                <a16:creationId xmlns:a16="http://schemas.microsoft.com/office/drawing/2014/main" id="{71E9E132-CE6A-C0E4-8DEC-A3BE4158472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9" t="12714" r="4952"/>
          <a:stretch/>
        </p:blipFill>
        <p:spPr>
          <a:xfrm>
            <a:off x="251859" y="567889"/>
            <a:ext cx="8617591" cy="4466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037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4</TotalTime>
  <Words>55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g Dai</dc:creator>
  <cp:lastModifiedBy>Ying Dai</cp:lastModifiedBy>
  <cp:revision>4</cp:revision>
  <dcterms:created xsi:type="dcterms:W3CDTF">2023-12-11T13:09:18Z</dcterms:created>
  <dcterms:modified xsi:type="dcterms:W3CDTF">2023-12-11T14:00:11Z</dcterms:modified>
</cp:coreProperties>
</file>